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6858000" cy="9144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51F"/>
    <a:srgbClr val="00E702"/>
    <a:srgbClr val="609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22"/>
    <p:restoredTop sz="91301"/>
  </p:normalViewPr>
  <p:slideViewPr>
    <p:cSldViewPr snapToGrid="0" snapToObjects="1">
      <p:cViewPr>
        <p:scale>
          <a:sx n="100" d="100"/>
          <a:sy n="100" d="100"/>
        </p:scale>
        <p:origin x="3152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0" name="Shape 11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74212362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Arial"/>
      </a:defRPr>
    </a:lvl1pPr>
    <a:lvl2pPr indent="228600" latinLnBrk="0">
      <a:defRPr sz="1200">
        <a:latin typeface="+mn-lt"/>
        <a:ea typeface="+mn-ea"/>
        <a:cs typeface="+mn-cs"/>
        <a:sym typeface="Arial"/>
      </a:defRPr>
    </a:lvl2pPr>
    <a:lvl3pPr indent="457200" latinLnBrk="0">
      <a:defRPr sz="1200">
        <a:latin typeface="+mn-lt"/>
        <a:ea typeface="+mn-ea"/>
        <a:cs typeface="+mn-cs"/>
        <a:sym typeface="Arial"/>
      </a:defRPr>
    </a:lvl3pPr>
    <a:lvl4pPr indent="685800" latinLnBrk="0">
      <a:defRPr sz="1200">
        <a:latin typeface="+mn-lt"/>
        <a:ea typeface="+mn-ea"/>
        <a:cs typeface="+mn-cs"/>
        <a:sym typeface="Arial"/>
      </a:defRPr>
    </a:lvl4pPr>
    <a:lvl5pPr indent="914400" latinLnBrk="0">
      <a:defRPr sz="1200">
        <a:latin typeface="+mn-lt"/>
        <a:ea typeface="+mn-ea"/>
        <a:cs typeface="+mn-cs"/>
        <a:sym typeface="Arial"/>
      </a:defRPr>
    </a:lvl5pPr>
    <a:lvl6pPr indent="1143000" latinLnBrk="0">
      <a:defRPr sz="1200">
        <a:latin typeface="+mn-lt"/>
        <a:ea typeface="+mn-ea"/>
        <a:cs typeface="+mn-cs"/>
        <a:sym typeface="Arial"/>
      </a:defRPr>
    </a:lvl6pPr>
    <a:lvl7pPr indent="1371600" latinLnBrk="0">
      <a:defRPr sz="1200">
        <a:latin typeface="+mn-lt"/>
        <a:ea typeface="+mn-ea"/>
        <a:cs typeface="+mn-cs"/>
        <a:sym typeface="Arial"/>
      </a:defRPr>
    </a:lvl7pPr>
    <a:lvl8pPr indent="1600200" latinLnBrk="0">
      <a:defRPr sz="1200">
        <a:latin typeface="+mn-lt"/>
        <a:ea typeface="+mn-ea"/>
        <a:cs typeface="+mn-cs"/>
        <a:sym typeface="Arial"/>
      </a:defRPr>
    </a:lvl8pPr>
    <a:lvl9pPr indent="1828800" latinLnBrk="0">
      <a:defRPr sz="12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514350" y="2840568"/>
            <a:ext cx="5829300" cy="1960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4972050" y="366185"/>
            <a:ext cx="1543050" cy="7802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366185"/>
            <a:ext cx="4514850" cy="7802035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541736" y="5875867"/>
            <a:ext cx="5829301" cy="1816101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541736" y="3875617"/>
            <a:ext cx="5829301" cy="2000251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342900" y="2133600"/>
            <a:ext cx="3028950" cy="6034619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42900" y="2046817"/>
            <a:ext cx="3030142" cy="853017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3483769" y="2046816"/>
            <a:ext cx="3031332" cy="853016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342901" y="364068"/>
            <a:ext cx="2256235" cy="1549401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2681286" y="364067"/>
            <a:ext cx="3833814" cy="7804152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half" idx="13"/>
          </p:nvPr>
        </p:nvSpPr>
        <p:spPr>
          <a:xfrm>
            <a:off x="342901" y="1913468"/>
            <a:ext cx="2256235" cy="625475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1344217" y="6400801"/>
            <a:ext cx="4114801" cy="755652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344217" y="817033"/>
            <a:ext cx="4114801" cy="5486401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44217" y="7156450"/>
            <a:ext cx="4114801" cy="1073151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42900" y="366185"/>
            <a:ext cx="6172200" cy="1524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230411" y="8580052"/>
            <a:ext cx="284691" cy="276999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  <a:latin typeface="+mn-lt"/>
                <a:ea typeface="+mn-ea"/>
                <a:cs typeface="+mn-cs"/>
                <a:sym typeface="Arial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med"/>
  <p:txStyles>
    <p:titleStyle>
      <a:lvl1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titleStyle>
    <p:bodyStyle>
      <a:lvl1pPr marL="342900" marR="0" indent="-3429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783771" marR="0" indent="-326571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1219200" marR="0" indent="-3048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17373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21945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26517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31089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35661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40233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8022A45-BC68-B34C-B13F-9ED9A9D2B7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8133" y="6501410"/>
            <a:ext cx="2171646" cy="2083789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EACAE5BC-068C-5D4F-A078-C6FDEC078636}"/>
              </a:ext>
            </a:extLst>
          </p:cNvPr>
          <p:cNvGrpSpPr/>
          <p:nvPr/>
        </p:nvGrpSpPr>
        <p:grpSpPr>
          <a:xfrm>
            <a:off x="1265017" y="1310197"/>
            <a:ext cx="4625595" cy="2528427"/>
            <a:chOff x="1306685" y="1009127"/>
            <a:chExt cx="4625595" cy="2528427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811F63A-0A6C-F843-A079-E94D791BDD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06685" y="1058674"/>
              <a:ext cx="3468509" cy="247888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98FE34A-20FF-764B-BF56-D473271C24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26713"/>
            <a:stretch/>
          </p:blipFill>
          <p:spPr>
            <a:xfrm>
              <a:off x="4933942" y="1258887"/>
              <a:ext cx="348441" cy="36576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0510A8B-DDED-0148-83D4-DA878F8188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9751"/>
            <a:stretch/>
          </p:blipFill>
          <p:spPr>
            <a:xfrm>
              <a:off x="4933943" y="1660144"/>
              <a:ext cx="335083" cy="36576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A9494EB8-1C02-D249-9537-4E515D95C66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22527" y="2117113"/>
              <a:ext cx="338853" cy="36576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8F48F2F-15CC-C949-B505-B58748C36D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25769"/>
            <a:stretch/>
          </p:blipFill>
          <p:spPr>
            <a:xfrm>
              <a:off x="4915915" y="2570593"/>
              <a:ext cx="344130" cy="36576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A06DBB5-985E-5E4C-9956-9D3321436D2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733943" y="1009127"/>
              <a:ext cx="430997" cy="304852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F9583D77-E81B-C442-B7C6-32C10DA9DE2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099067" y="1038432"/>
              <a:ext cx="241369" cy="29165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366CBDC-10A6-E440-89BF-A4F288DFA30C}"/>
                </a:ext>
              </a:extLst>
            </p:cNvPr>
            <p:cNvSpPr txBox="1"/>
            <p:nvPr/>
          </p:nvSpPr>
          <p:spPr>
            <a:xfrm>
              <a:off x="5219751" y="1375393"/>
              <a:ext cx="367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C1B626B-8E33-4F4D-A9E6-2D118C5FD945}"/>
                </a:ext>
              </a:extLst>
            </p:cNvPr>
            <p:cNvSpPr txBox="1"/>
            <p:nvPr/>
          </p:nvSpPr>
          <p:spPr>
            <a:xfrm>
              <a:off x="5219751" y="1800753"/>
              <a:ext cx="56618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BS/Aβo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7F7057B-9116-F94A-B2B3-297EFE72F326}"/>
                </a:ext>
              </a:extLst>
            </p:cNvPr>
            <p:cNvSpPr txBox="1"/>
            <p:nvPr/>
          </p:nvSpPr>
          <p:spPr>
            <a:xfrm>
              <a:off x="5207109" y="2220758"/>
              <a:ext cx="5261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SCexo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35B55C6-BE21-E247-B769-41916CBE92C5}"/>
                </a:ext>
              </a:extLst>
            </p:cNvPr>
            <p:cNvSpPr txBox="1"/>
            <p:nvPr/>
          </p:nvSpPr>
          <p:spPr>
            <a:xfrm>
              <a:off x="5207402" y="2688746"/>
              <a:ext cx="7248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SCexo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/Aβo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D3A96FC1-1388-2246-92AC-80A22797AE72}"/>
              </a:ext>
            </a:extLst>
          </p:cNvPr>
          <p:cNvGrpSpPr/>
          <p:nvPr/>
        </p:nvGrpSpPr>
        <p:grpSpPr>
          <a:xfrm>
            <a:off x="1265017" y="3959626"/>
            <a:ext cx="4618880" cy="2519631"/>
            <a:chOff x="1265017" y="3759571"/>
            <a:chExt cx="4618880" cy="251963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203F135-24E6-FD4D-837E-A6C640F64E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65017" y="3759763"/>
              <a:ext cx="3530144" cy="2519439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8703DF3-7493-204D-982D-7B5ED0CFF76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925224" y="5452514"/>
              <a:ext cx="345298" cy="364751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E1608B0-246D-7C42-8743-7D50A1B5AD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25769"/>
            <a:stretch/>
          </p:blipFill>
          <p:spPr>
            <a:xfrm>
              <a:off x="4936156" y="4138067"/>
              <a:ext cx="344011" cy="36576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F71EFBD6-BBAE-2A47-8873-2D2F9714BE1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45818" y="5012606"/>
              <a:ext cx="302409" cy="36576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5EA5084-CF3E-CB41-AE46-370BD98E0F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b="17560"/>
            <a:stretch/>
          </p:blipFill>
          <p:spPr>
            <a:xfrm>
              <a:off x="4931997" y="4587256"/>
              <a:ext cx="308884" cy="36576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B67C2EF7-D43D-3845-92B4-368B16369BE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736716" y="3759571"/>
              <a:ext cx="430997" cy="304852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B1E64B57-C61E-5148-9A0D-C1EB2DB7283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134611" y="3777394"/>
              <a:ext cx="241369" cy="291654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6E9A30F-9B8E-2C4D-9C1A-DDEFB828F8C2}"/>
                </a:ext>
              </a:extLst>
            </p:cNvPr>
            <p:cNvSpPr txBox="1"/>
            <p:nvPr/>
          </p:nvSpPr>
          <p:spPr>
            <a:xfrm>
              <a:off x="5221102" y="4213669"/>
              <a:ext cx="3674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BB994A8-8BC7-6E4B-B877-9150FAE8672B}"/>
                </a:ext>
              </a:extLst>
            </p:cNvPr>
            <p:cNvSpPr txBox="1"/>
            <p:nvPr/>
          </p:nvSpPr>
          <p:spPr>
            <a:xfrm>
              <a:off x="5219751" y="4679512"/>
              <a:ext cx="56618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BS/Aβo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A5A3E60-C116-EB49-915D-96B2522F0AA7}"/>
                </a:ext>
              </a:extLst>
            </p:cNvPr>
            <p:cNvSpPr txBox="1"/>
            <p:nvPr/>
          </p:nvSpPr>
          <p:spPr>
            <a:xfrm>
              <a:off x="5207109" y="5123027"/>
              <a:ext cx="47801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Nexo</a:t>
              </a:r>
              <a:endParaRPr 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399F7C6-59F7-324A-A207-408792FA4C54}"/>
                </a:ext>
              </a:extLst>
            </p:cNvPr>
            <p:cNvSpPr txBox="1"/>
            <p:nvPr/>
          </p:nvSpPr>
          <p:spPr>
            <a:xfrm>
              <a:off x="5207109" y="5538537"/>
              <a:ext cx="6767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Nexo</a:t>
              </a:r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/Aβo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9550C540-E104-1442-8035-8BF18E2BED6A}"/>
              </a:ext>
            </a:extLst>
          </p:cNvPr>
          <p:cNvSpPr txBox="1"/>
          <p:nvPr/>
        </p:nvSpPr>
        <p:spPr>
          <a:xfrm>
            <a:off x="117030" y="228600"/>
            <a:ext cx="1634420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Supplemental Figure 3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EA64807-4EFF-3247-9DC6-B84B23E29EFC}"/>
              </a:ext>
            </a:extLst>
          </p:cNvPr>
          <p:cNvGrpSpPr/>
          <p:nvPr/>
        </p:nvGrpSpPr>
        <p:grpSpPr>
          <a:xfrm>
            <a:off x="1414142" y="655152"/>
            <a:ext cx="3778250" cy="518583"/>
            <a:chOff x="1414142" y="655152"/>
            <a:chExt cx="3778250" cy="518583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6BB4D0FC-F10A-E546-86DB-3E16F02302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414142" y="655152"/>
              <a:ext cx="3778250" cy="518583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5F66AE0-12DD-1C42-807F-A51134FD71CB}"/>
                </a:ext>
              </a:extLst>
            </p:cNvPr>
            <p:cNvSpPr txBox="1"/>
            <p:nvPr/>
          </p:nvSpPr>
          <p:spPr>
            <a:xfrm>
              <a:off x="2129742" y="678302"/>
              <a:ext cx="249425" cy="137160"/>
            </a:xfrm>
            <a:prstGeom prst="rect">
              <a:avLst/>
            </a:prstGeom>
            <a:solidFill>
              <a:schemeClr val="bg1"/>
            </a:solidFill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1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Calibri"/>
                </a:rPr>
                <a:t>4 </a:t>
              </a:r>
              <a:r>
                <a:rPr kumimoji="0" lang="en-US" sz="700" b="1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Calibri"/>
                </a:rPr>
                <a:t>hr</a:t>
              </a:r>
              <a:endParaRPr kumimoji="0" lang="en-US" sz="7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Calibri"/>
              </a:endParaRP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1D91C865-9269-2F4C-A586-7DE9278F71E1}"/>
              </a:ext>
            </a:extLst>
          </p:cNvPr>
          <p:cNvSpPr txBox="1"/>
          <p:nvPr/>
        </p:nvSpPr>
        <p:spPr>
          <a:xfrm>
            <a:off x="844083" y="626532"/>
            <a:ext cx="389733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8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ea typeface="Calibri"/>
                <a:cs typeface="Calibri"/>
                <a:sym typeface="Calibri"/>
              </a:rPr>
              <a:t>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D4EECE3-8717-F045-B915-E31FF1989EC6}"/>
              </a:ext>
            </a:extLst>
          </p:cNvPr>
          <p:cNvSpPr txBox="1"/>
          <p:nvPr/>
        </p:nvSpPr>
        <p:spPr>
          <a:xfrm>
            <a:off x="844083" y="1397800"/>
            <a:ext cx="389733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800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ea typeface="Calibri"/>
                <a:cs typeface="Calibri"/>
                <a:sym typeface="Calibri"/>
              </a:rPr>
              <a:t>B</a:t>
            </a:r>
            <a:endParaRPr kumimoji="0" lang="en-US" sz="18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1E81799-8B8E-0047-AE44-FC8D53B308CE}"/>
              </a:ext>
            </a:extLst>
          </p:cNvPr>
          <p:cNvSpPr txBox="1"/>
          <p:nvPr/>
        </p:nvSpPr>
        <p:spPr>
          <a:xfrm>
            <a:off x="844083" y="3997067"/>
            <a:ext cx="389733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800" b="1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ea typeface="Calibri"/>
                <a:cs typeface="Calibri"/>
                <a:sym typeface="Calibri"/>
              </a:rPr>
              <a:t>C</a:t>
            </a:r>
            <a:endParaRPr kumimoji="0" lang="en-US" sz="18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37CBE08-7820-BD47-A6FC-75EA9ABF0521}"/>
              </a:ext>
            </a:extLst>
          </p:cNvPr>
          <p:cNvSpPr txBox="1"/>
          <p:nvPr/>
        </p:nvSpPr>
        <p:spPr>
          <a:xfrm>
            <a:off x="923352" y="6609547"/>
            <a:ext cx="389733" cy="3693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8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/>
                <a:ea typeface="Calibri"/>
                <a:cs typeface="Calibri"/>
                <a:sym typeface="Calibri"/>
              </a:rPr>
              <a:t>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0E449BD-A859-464E-A30B-14C6C2655EE1}"/>
              </a:ext>
            </a:extLst>
          </p:cNvPr>
          <p:cNvSpPr txBox="1"/>
          <p:nvPr/>
        </p:nvSpPr>
        <p:spPr>
          <a:xfrm>
            <a:off x="1562580" y="1282166"/>
            <a:ext cx="1381145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ea"/>
                <a:ea typeface="+mn-ea"/>
                <a:cs typeface="Calibri"/>
                <a:sym typeface="Calibri"/>
              </a:rPr>
              <a:t>NSC-derived exosome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8B406CF-72FD-5647-AA48-17C2504D5B42}"/>
              </a:ext>
            </a:extLst>
          </p:cNvPr>
          <p:cNvSpPr txBox="1"/>
          <p:nvPr/>
        </p:nvSpPr>
        <p:spPr>
          <a:xfrm>
            <a:off x="1597303" y="3899162"/>
            <a:ext cx="1317025" cy="230830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900" b="1" dirty="0">
                <a:latin typeface="+mn-lt"/>
              </a:rPr>
              <a:t>MN</a:t>
            </a:r>
            <a:r>
              <a:rPr kumimoji="0" lang="en-US" sz="9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-derived exosomes</a:t>
            </a:r>
          </a:p>
        </p:txBody>
      </p:sp>
    </p:spTree>
    <p:extLst>
      <p:ext uri="{BB962C8B-B14F-4D97-AF65-F5344CB8AC3E}">
        <p14:creationId xmlns:p14="http://schemas.microsoft.com/office/powerpoint/2010/main" val="1225375815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03</TotalTime>
  <Words>29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icci, Maria A.</cp:lastModifiedBy>
  <cp:revision>176</cp:revision>
  <cp:lastPrinted>2019-04-15T16:22:02Z</cp:lastPrinted>
  <dcterms:modified xsi:type="dcterms:W3CDTF">2019-05-08T23:02:35Z</dcterms:modified>
</cp:coreProperties>
</file>